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62" r:id="rId3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1392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BCD317-4B6D-4972-8E49-4A20C3D920E3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F7EBD9-C85A-4151-86E0-055471BC472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99477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6F900A-06E6-486D-8730-8EFE0433F940}" type="slidenum">
              <a:rPr lang="el-GR" smtClean="0"/>
              <a:t>2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077952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K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Kλικ για επεξεργασία των στυλ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FE191-EE8B-4C92-90C9-3ED5925174D5}" type="datetimeFigureOut">
              <a:rPr lang="el-GR" smtClean="0"/>
              <a:t>14/5/2019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3D55B-0F70-45D8-AC58-66827E4291B6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4 - TextBox"/>
          <p:cNvSpPr txBox="1"/>
          <p:nvPr/>
        </p:nvSpPr>
        <p:spPr>
          <a:xfrm>
            <a:off x="1465843" y="4491915"/>
            <a:ext cx="91083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p=0.174</a:t>
            </a:r>
            <a:endParaRPr lang="el-GR" sz="15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38"/>
          <p:cNvSpPr txBox="1">
            <a:spLocks noChangeArrowheads="1"/>
          </p:cNvSpPr>
          <p:nvPr/>
        </p:nvSpPr>
        <p:spPr bwMode="auto">
          <a:xfrm>
            <a:off x="884347" y="5540833"/>
            <a:ext cx="41197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rIns="3600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spcAft>
                <a:spcPts val="1600"/>
              </a:spcAft>
              <a:buFontTx/>
              <a:buNone/>
            </a:pP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25         5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    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        12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52046" y="1967991"/>
            <a:ext cx="4411647" cy="4053297"/>
            <a:chOff x="4421356" y="1008000"/>
            <a:chExt cx="4650708" cy="4240737"/>
          </a:xfrm>
        </p:grpSpPr>
        <p:grpSp>
          <p:nvGrpSpPr>
            <p:cNvPr id="7" name="Group 6"/>
            <p:cNvGrpSpPr/>
            <p:nvPr/>
          </p:nvGrpSpPr>
          <p:grpSpPr>
            <a:xfrm>
              <a:off x="4644000" y="1008000"/>
              <a:ext cx="4428064" cy="3825136"/>
              <a:chOff x="4644000" y="1008000"/>
              <a:chExt cx="4428064" cy="3825136"/>
            </a:xfrm>
          </p:grpSpPr>
          <p:cxnSp>
            <p:nvCxnSpPr>
              <p:cNvPr id="10" name="Straight Connector 9"/>
              <p:cNvCxnSpPr/>
              <p:nvPr/>
            </p:nvCxnSpPr>
            <p:spPr>
              <a:xfrm>
                <a:off x="5148000" y="1008000"/>
                <a:ext cx="0" cy="3636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5148064" y="4653136"/>
                <a:ext cx="3924000" cy="21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flipH="1">
                <a:off x="4981546" y="1556792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flipH="1">
                <a:off x="5004000" y="2132856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 flipH="1">
                <a:off x="4983541" y="2708920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H="1">
                <a:off x="4968000" y="328498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 flipH="1">
                <a:off x="4983541" y="3861048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 flipH="1">
                <a:off x="4983541" y="436510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 flipV="1">
                <a:off x="543609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 flipV="1">
                <a:off x="6084168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flipV="1">
                <a:off x="6732240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flipV="1">
                <a:off x="7380312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 flipV="1">
                <a:off x="8028384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V="1">
                <a:off x="867645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4644000" y="4212000"/>
                <a:ext cx="50400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644000" y="370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2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644000" y="3132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4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4644008" y="2574063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6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4644000" y="1944000"/>
                <a:ext cx="504000" cy="360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8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644000" y="136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6084168" y="4925572"/>
              <a:ext cx="223224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of follow-up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421356" y="1008000"/>
              <a:ext cx="438013" cy="302271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gression-free survival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4499992" y="1463935"/>
            <a:ext cx="4464496" cy="4629361"/>
            <a:chOff x="4365643" y="427235"/>
            <a:chExt cx="4706421" cy="4843440"/>
          </a:xfrm>
        </p:grpSpPr>
        <p:grpSp>
          <p:nvGrpSpPr>
            <p:cNvPr id="31" name="Group 30"/>
            <p:cNvGrpSpPr/>
            <p:nvPr/>
          </p:nvGrpSpPr>
          <p:grpSpPr>
            <a:xfrm>
              <a:off x="4644000" y="1008000"/>
              <a:ext cx="4428064" cy="3825136"/>
              <a:chOff x="4644000" y="1008000"/>
              <a:chExt cx="4428064" cy="3825136"/>
            </a:xfrm>
          </p:grpSpPr>
          <p:cxnSp>
            <p:nvCxnSpPr>
              <p:cNvPr id="34" name="Straight Connector 33"/>
              <p:cNvCxnSpPr/>
              <p:nvPr/>
            </p:nvCxnSpPr>
            <p:spPr>
              <a:xfrm>
                <a:off x="5148000" y="1008000"/>
                <a:ext cx="0" cy="3636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5148064" y="4653136"/>
                <a:ext cx="3924000" cy="21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 flipH="1">
                <a:off x="4981546" y="1556792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 flipH="1">
                <a:off x="5004000" y="2132856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 flipH="1">
                <a:off x="4983541" y="2708920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 flipH="1">
                <a:off x="4968000" y="328498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 flipH="1">
                <a:off x="4983541" y="3861048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 flipH="1">
                <a:off x="4983541" y="436510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 flipV="1">
                <a:off x="543609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flipV="1">
                <a:off x="6084168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 flipV="1">
                <a:off x="6732240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 flipV="1">
                <a:off x="7380312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 flipV="1">
                <a:off x="8028384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/>
              <p:cNvCxnSpPr/>
              <p:nvPr/>
            </p:nvCxnSpPr>
            <p:spPr>
              <a:xfrm flipV="1">
                <a:off x="867645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8" name="TextBox 47"/>
              <p:cNvSpPr txBox="1"/>
              <p:nvPr/>
            </p:nvSpPr>
            <p:spPr>
              <a:xfrm>
                <a:off x="4644000" y="4212000"/>
                <a:ext cx="50400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644000" y="370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2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644000" y="3132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4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644008" y="2574063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6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4644000" y="1944000"/>
                <a:ext cx="504000" cy="360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8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4644000" y="136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6084168" y="4947510"/>
              <a:ext cx="223224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of follow-up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365643" y="427235"/>
              <a:ext cx="438013" cy="302271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4" name="TextBox 38"/>
          <p:cNvSpPr txBox="1">
            <a:spLocks noChangeArrowheads="1"/>
          </p:cNvSpPr>
          <p:nvPr/>
        </p:nvSpPr>
        <p:spPr bwMode="auto">
          <a:xfrm>
            <a:off x="5364088" y="5568391"/>
            <a:ext cx="41197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rIns="3600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spcAft>
                <a:spcPts val="1600"/>
              </a:spcAft>
              <a:buFontTx/>
              <a:buNone/>
            </a:pP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          25         5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    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        12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</a:p>
        </p:txBody>
      </p:sp>
      <p:sp>
        <p:nvSpPr>
          <p:cNvPr id="55" name="9 - TextBox"/>
          <p:cNvSpPr txBox="1"/>
          <p:nvPr/>
        </p:nvSpPr>
        <p:spPr>
          <a:xfrm>
            <a:off x="5738077" y="4423066"/>
            <a:ext cx="91083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p=0.171</a:t>
            </a:r>
            <a:endParaRPr lang="el-GR" sz="15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67544" y="119675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l-GR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5240302" y="124861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r>
              <a:rPr lang="en-US" b="1" dirty="0" smtClean="0"/>
              <a:t>)</a:t>
            </a:r>
            <a:endParaRPr lang="el-GR" b="1" dirty="0"/>
          </a:p>
        </p:txBody>
      </p:sp>
      <p:pic>
        <p:nvPicPr>
          <p:cNvPr id="67" name="Picture 66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48" t="7046" r="27910" b="56911"/>
          <a:stretch/>
        </p:blipFill>
        <p:spPr bwMode="auto">
          <a:xfrm>
            <a:off x="937536" y="2377024"/>
            <a:ext cx="3705225" cy="12668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0" name="TextBox 59"/>
          <p:cNvSpPr txBox="1"/>
          <p:nvPr/>
        </p:nvSpPr>
        <p:spPr>
          <a:xfrm>
            <a:off x="2555776" y="3254787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profile </a:t>
            </a:r>
            <a:r>
              <a:rPr lang="en-US" sz="10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555776" y="2708691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8" name="Picture 67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27" t="7588" r="27750" b="63414"/>
          <a:stretch/>
        </p:blipFill>
        <p:spPr bwMode="auto">
          <a:xfrm>
            <a:off x="5474219" y="2433275"/>
            <a:ext cx="3490270" cy="101917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9" name="13 - TextBox"/>
          <p:cNvSpPr txBox="1"/>
          <p:nvPr/>
        </p:nvSpPr>
        <p:spPr>
          <a:xfrm>
            <a:off x="0" y="0"/>
            <a:ext cx="23574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Suppl. Figure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el-GR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7596336" y="2610179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7586095" y="3008566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profile </a:t>
            </a:r>
            <a:r>
              <a:rPr lang="en-US" sz="10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25368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- TextBox"/>
          <p:cNvSpPr txBox="1"/>
          <p:nvPr/>
        </p:nvSpPr>
        <p:spPr>
          <a:xfrm>
            <a:off x="1465843" y="4491915"/>
            <a:ext cx="91083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p=0.087</a:t>
            </a:r>
            <a:endParaRPr lang="el-GR" sz="15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38"/>
          <p:cNvSpPr txBox="1">
            <a:spLocks noChangeArrowheads="1"/>
          </p:cNvSpPr>
          <p:nvPr/>
        </p:nvSpPr>
        <p:spPr bwMode="auto">
          <a:xfrm>
            <a:off x="884347" y="5540833"/>
            <a:ext cx="41197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rIns="3600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spcAft>
                <a:spcPts val="1600"/>
              </a:spcAft>
              <a:buFontTx/>
              <a:buNone/>
            </a:pP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25         5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    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        12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</a:p>
        </p:txBody>
      </p:sp>
      <p:grpSp>
        <p:nvGrpSpPr>
          <p:cNvPr id="41" name="Group 40"/>
          <p:cNvGrpSpPr/>
          <p:nvPr/>
        </p:nvGrpSpPr>
        <p:grpSpPr>
          <a:xfrm>
            <a:off x="52046" y="1967991"/>
            <a:ext cx="4411647" cy="4053297"/>
            <a:chOff x="4421356" y="1008000"/>
            <a:chExt cx="4650708" cy="4240737"/>
          </a:xfrm>
        </p:grpSpPr>
        <p:grpSp>
          <p:nvGrpSpPr>
            <p:cNvPr id="38" name="Group 37"/>
            <p:cNvGrpSpPr/>
            <p:nvPr/>
          </p:nvGrpSpPr>
          <p:grpSpPr>
            <a:xfrm>
              <a:off x="4644000" y="1008000"/>
              <a:ext cx="4428064" cy="3825136"/>
              <a:chOff x="4644000" y="1008000"/>
              <a:chExt cx="4428064" cy="3825136"/>
            </a:xfrm>
          </p:grpSpPr>
          <p:cxnSp>
            <p:nvCxnSpPr>
              <p:cNvPr id="7" name="Straight Connector 6"/>
              <p:cNvCxnSpPr/>
              <p:nvPr/>
            </p:nvCxnSpPr>
            <p:spPr>
              <a:xfrm>
                <a:off x="5148000" y="1008000"/>
                <a:ext cx="0" cy="3636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5148064" y="4653136"/>
                <a:ext cx="3924000" cy="21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 flipH="1">
                <a:off x="4981546" y="1556792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 flipH="1">
                <a:off x="5004000" y="2132856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flipH="1">
                <a:off x="4983541" y="2708920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flipH="1">
                <a:off x="4968000" y="328498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 flipH="1">
                <a:off x="4983541" y="3861048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H="1">
                <a:off x="4983541" y="436510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 flipV="1">
                <a:off x="543609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V="1">
                <a:off x="6084168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flipV="1">
                <a:off x="6732240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 flipV="1">
                <a:off x="7380312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 flipV="1">
                <a:off x="8028384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V="1">
                <a:off x="867645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4644000" y="4212000"/>
                <a:ext cx="50400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644000" y="370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2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644000" y="3132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4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4644008" y="2574063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6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644000" y="1944000"/>
                <a:ext cx="504000" cy="360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8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644000" y="136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9" name="TextBox 38"/>
            <p:cNvSpPr txBox="1"/>
            <p:nvPr/>
          </p:nvSpPr>
          <p:spPr>
            <a:xfrm>
              <a:off x="6084168" y="4925572"/>
              <a:ext cx="223224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of follow-up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421356" y="1008000"/>
              <a:ext cx="438013" cy="302271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gression-free survival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4499992" y="1463935"/>
            <a:ext cx="4464496" cy="4629361"/>
            <a:chOff x="4365643" y="427235"/>
            <a:chExt cx="4706421" cy="4843440"/>
          </a:xfrm>
        </p:grpSpPr>
        <p:grpSp>
          <p:nvGrpSpPr>
            <p:cNvPr id="74" name="Group 73"/>
            <p:cNvGrpSpPr/>
            <p:nvPr/>
          </p:nvGrpSpPr>
          <p:grpSpPr>
            <a:xfrm>
              <a:off x="4644000" y="1008000"/>
              <a:ext cx="4428064" cy="3825136"/>
              <a:chOff x="4644000" y="1008000"/>
              <a:chExt cx="4428064" cy="3825136"/>
            </a:xfrm>
          </p:grpSpPr>
          <p:cxnSp>
            <p:nvCxnSpPr>
              <p:cNvPr id="77" name="Straight Connector 76"/>
              <p:cNvCxnSpPr/>
              <p:nvPr/>
            </p:nvCxnSpPr>
            <p:spPr>
              <a:xfrm>
                <a:off x="5148000" y="1008000"/>
                <a:ext cx="0" cy="3636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5148064" y="4653136"/>
                <a:ext cx="3924000" cy="214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 flipH="1">
                <a:off x="4981546" y="1556792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 flipH="1">
                <a:off x="5004000" y="2132856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 flipH="1">
                <a:off x="4983541" y="2708920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 flipH="1">
                <a:off x="4968000" y="328498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 flipH="1">
                <a:off x="4983541" y="3861048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 flipH="1">
                <a:off x="4983541" y="4365104"/>
                <a:ext cx="16452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 flipV="1">
                <a:off x="543609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 flipV="1">
                <a:off x="6084168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 flipV="1">
                <a:off x="6732240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 flipV="1">
                <a:off x="7380312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 flipV="1">
                <a:off x="8028384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 flipV="1">
                <a:off x="8676456" y="4653136"/>
                <a:ext cx="0" cy="180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1" name="TextBox 90"/>
              <p:cNvSpPr txBox="1"/>
              <p:nvPr/>
            </p:nvSpPr>
            <p:spPr>
              <a:xfrm>
                <a:off x="4644000" y="4212000"/>
                <a:ext cx="50400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4644000" y="370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2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4644000" y="3132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4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4644008" y="2574063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6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4644000" y="1944000"/>
                <a:ext cx="504000" cy="360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,8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4644000" y="1368000"/>
                <a:ext cx="54912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0</a:t>
                </a:r>
                <a:endParaRPr lang="el-GR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5" name="TextBox 74"/>
            <p:cNvSpPr txBox="1"/>
            <p:nvPr/>
          </p:nvSpPr>
          <p:spPr>
            <a:xfrm>
              <a:off x="6084168" y="4947510"/>
              <a:ext cx="223224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of follow-up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365643" y="427235"/>
              <a:ext cx="438013" cy="302271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lang="el-GR" sz="1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7" name="TextBox 38"/>
          <p:cNvSpPr txBox="1">
            <a:spLocks noChangeArrowheads="1"/>
          </p:cNvSpPr>
          <p:nvPr/>
        </p:nvSpPr>
        <p:spPr bwMode="auto">
          <a:xfrm>
            <a:off x="5364088" y="5568391"/>
            <a:ext cx="41197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rIns="3600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tabLst>
                <a:tab pos="715963" algn="l"/>
                <a:tab pos="720725" algn="l"/>
                <a:tab pos="1520825" algn="l"/>
                <a:tab pos="1524000" algn="l"/>
                <a:tab pos="2241550" algn="l"/>
                <a:tab pos="2597150" algn="l"/>
                <a:tab pos="3051175" algn="l"/>
                <a:tab pos="3228975" algn="l"/>
                <a:tab pos="3849688" algn="l"/>
                <a:tab pos="4572000" algn="l"/>
              </a:tabLst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spcAft>
                <a:spcPts val="1600"/>
              </a:spcAft>
              <a:buFontTx/>
              <a:buNone/>
            </a:pP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          25         50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    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  <a:r>
              <a:rPr lang="en-US" altLang="el-G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0        125</a:t>
            </a:r>
            <a:r>
              <a:rPr lang="en-US" alt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 </a:t>
            </a:r>
          </a:p>
        </p:txBody>
      </p:sp>
      <p:sp>
        <p:nvSpPr>
          <p:cNvPr id="100" name="9 - TextBox"/>
          <p:cNvSpPr txBox="1"/>
          <p:nvPr/>
        </p:nvSpPr>
        <p:spPr>
          <a:xfrm>
            <a:off x="5738077" y="4423066"/>
            <a:ext cx="91083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p=0.118</a:t>
            </a:r>
            <a:endParaRPr lang="el-GR" sz="15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67544" y="119675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r>
              <a:rPr lang="en-US" b="1" dirty="0" smtClean="0"/>
              <a:t>)</a:t>
            </a:r>
            <a:endParaRPr lang="el-GR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5240302" y="124861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  <a:r>
              <a:rPr lang="en-US" b="1" dirty="0" smtClean="0"/>
              <a:t>)</a:t>
            </a:r>
            <a:endParaRPr lang="el-GR" b="1" dirty="0"/>
          </a:p>
        </p:txBody>
      </p:sp>
      <p:pic>
        <p:nvPicPr>
          <p:cNvPr id="63" name="Picture 62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88" t="5962" r="28070" b="43360"/>
          <a:stretch/>
        </p:blipFill>
        <p:spPr bwMode="auto">
          <a:xfrm>
            <a:off x="934067" y="2348880"/>
            <a:ext cx="3705225" cy="178117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2674718" y="2724076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005066" y="2423521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Cell profile </a:t>
            </a:r>
            <a:r>
              <a:rPr lang="en-US" sz="10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459785" y="3140588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484954" y="3756928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8" name="Picture 67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10" t="5691" r="27751" b="53929"/>
          <a:stretch/>
        </p:blipFill>
        <p:spPr bwMode="auto">
          <a:xfrm>
            <a:off x="5421487" y="2420888"/>
            <a:ext cx="3526451" cy="140386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9" name="TextBox 68"/>
          <p:cNvSpPr txBox="1"/>
          <p:nvPr/>
        </p:nvSpPr>
        <p:spPr>
          <a:xfrm>
            <a:off x="6140643" y="2307266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7308304" y="2564904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).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7231580" y="2956317"/>
            <a:ext cx="12468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endParaRPr lang="en-U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6955697" y="3645024"/>
            <a:ext cx="4608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ST1</a:t>
            </a:r>
            <a:r>
              <a:rPr lang="el-G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 Cell profile </a:t>
            </a:r>
            <a:r>
              <a:rPr lang="en-US" sz="1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+)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1589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4</TotalTime>
  <Words>154</Words>
  <Application>Microsoft Office PowerPoint</Application>
  <PresentationFormat>On-screen Show (4:3)</PresentationFormat>
  <Paragraphs>5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Θέμα του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Διαφάνεια 1</dc:title>
  <dc:creator>Areti</dc:creator>
  <cp:lastModifiedBy>Areti Strati</cp:lastModifiedBy>
  <cp:revision>24</cp:revision>
  <dcterms:created xsi:type="dcterms:W3CDTF">2018-10-15T10:34:26Z</dcterms:created>
  <dcterms:modified xsi:type="dcterms:W3CDTF">2019-05-14T13:06:07Z</dcterms:modified>
</cp:coreProperties>
</file>